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7DB184-E5CD-475D-BCF7-30B688B6CC7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B7B048-0C46-4BE6-95BA-BD99B40F4CE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49A2B7-26A5-4A73-B4A3-AAD3C4B9D17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306087-2AEB-4B4A-B1F1-90A85CF23AC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F1B9A9-B7FB-4FD9-88D1-D4F50DC03CE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8944BF-4C84-4902-9EBE-652B4AE49C4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B81642-74C3-43A4-A8C3-6B2D0EECCC0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7C7652-C678-4814-8045-BC5F16B874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C9AC10-B47B-406D-BA67-1BD2FA455EA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2A800B-A891-48A8-96CB-9CB906CC34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41275C-FEFA-4EE9-AFE0-36F9355EAB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F0AD39-C134-438C-B58D-6E8E2CBA72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ADDCA26-8A9D-417A-BFB3-D6560FA50C2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826920" y="476280"/>
            <a:ext cx="7220160" cy="419400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755640" y="5143320"/>
            <a:ext cx="7704000" cy="89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2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Supplemental Figure 4. GO categories of genes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differentially expressed in A/MSG and PSG.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 The GO functional categories for differentially expressed genes exhibited significant differences; most of these genes  were associated with binding and catalytic function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2-17T17:16:49Z</dcterms:created>
  <dc:creator>番茄花园</dc:creator>
  <dc:description/>
  <dc:language>en-US</dc:language>
  <cp:lastModifiedBy>chengdj</cp:lastModifiedBy>
  <dcterms:modified xsi:type="dcterms:W3CDTF">2007-06-12T19:13:22Z</dcterms:modified>
  <cp:revision>8</cp:revision>
  <dc:subject/>
  <dc:title>幻灯片 1</dc:title>
</cp:coreProperties>
</file>